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09" r:id="rId2"/>
    <p:sldId id="310" r:id="rId3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43"/>
  </p:normalViewPr>
  <p:slideViewPr>
    <p:cSldViewPr snapToGrid="0" snapToObjects="1">
      <p:cViewPr varScale="1">
        <p:scale>
          <a:sx n="121" d="100"/>
          <a:sy n="121" d="100"/>
        </p:scale>
        <p:origin x="200" y="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E1B8E69-1283-3C49-9501-5B4D86FCF0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FC2DD2D-57C5-1641-BD23-E215AB0373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83408B7-C579-C247-9913-7F2B4CF73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6F08DFD-66E7-7D40-8F2E-1B37B037D9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00B6684-53AC-5B44-A8F5-5E9CA8529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213604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495BA7-2E8B-9A42-B552-A53254D9F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ADA4CEB-3D7E-0446-BCA0-749F97B80E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A01963D-2CC5-434F-A216-02A8EBE5F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0EDE349-E272-2445-8CAE-D68A4A143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AAA8842-4E3F-634A-92BC-FD71C1C5A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053544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79E9EFF-BB81-144D-A028-A76B0AF80D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51B620B-F43C-5A4C-8365-AEF8806B08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B3E3006-EB7B-0A46-8DD2-CB7C2EB4E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B7E4CFA-6BF9-4B43-8516-452B458789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6D1F2A2-B18C-4B48-BBAE-E2D29FEAC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058855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3C5E13F-6924-4E48-B6C1-790B7FBAE6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D7C0039-DA58-B942-9D66-E5F17D8A0B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82F873E-9C1D-7C43-B4D2-B840C8072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F5D3157-8E9D-FF4B-B33D-A6D902727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E00D8B8-0BE1-1647-B7A5-9F7A3E866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388000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9B971C1-5835-3248-AD78-ED198A69F1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0066F1D-E2F8-B549-A1EE-C65C877627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1F31438-9D6A-5746-B886-5BC6E990E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01B8475-0CAD-D94D-B4DE-2B7533111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E82CD0D-BFF9-614E-B71A-8EF7650E6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95678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7F626A1-FE70-1A43-8D49-41654C0F22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BCA0AA4-B6C1-334E-BDAB-5F4483F067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65709A5-7756-224B-8758-2D54FEFADC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A9E1EFA-6635-3F4F-A599-FD0664C7A1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9362DB3-A147-FD43-BA01-F758EAEC1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CFD091B-B9F3-0340-94B9-CDFC2119E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787924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B492D3-1A72-EA4C-9226-0617B3171C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1A51856-6B5E-554D-8C25-545763407C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C7EB00C-086D-3048-8684-5705589FF0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E34FB61F-BED6-BE47-9373-5501F9EACA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9B50CEFD-8B0E-6944-9639-EEA8D7F0C1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7D22679-08C1-0A40-92F6-A7F2CB7F0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8C733C34-94EF-9A4A-9960-30EFB3351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0CB7BC9F-CC13-5542-ADC8-DB0B92A75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102156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3D1AC97-D4B0-8E42-B37E-BC1F820910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87FB640-DB48-3644-BDE2-9A5482E61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C43630B-B694-0B43-874F-70A92BC3C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EDF0B701-B0DE-9444-9D90-BB6DAE103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354323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AC09F970-ADD7-FD4B-8DFA-912A5073D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322060A-EA69-5F4E-927C-0F9BD1686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693B695D-95E6-6E4C-B865-ADC8F6284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550424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41ED2BB-9BC3-7846-8911-27E13D276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23836D9-3AB1-6647-9800-AF7892B0EB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CC9407D-31DE-CC47-B6D0-171C2D6B16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447592D-59AE-D943-82E0-FDA8731E0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CCD9C09-2F34-8241-9A30-8A9456F93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A2F7162-EA1F-7B4E-9B63-B1B41EEAD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58087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326E13E-B81A-A64A-8A2A-62F9C9C37C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CF391BF3-5499-AF40-A251-EF96D39F9F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14D6009-0E67-6F45-A851-996D5BB985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1CF64F0-4E3E-3047-B7F0-EF05B39FB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E9E0F65-B297-EA46-A3F7-3656E0ACB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AB8E47B-ED30-C14D-AB94-D6633223F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193642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5AFDFE3-E32B-D444-9C0E-24ADA46452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0825624-FB51-E74D-85CC-929999F79E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es-ES"/>
              <a:t>Editar los estilos de texto del patrón
Segundo nivel
Tercer nivel
Cuarto nivel
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69C3F7B-E628-0148-A554-E630A273A2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722E4-C0EF-0946-BCE4-0D32D777AC4E}" type="datetimeFigureOut">
              <a:rPr lang="es-CO" smtClean="0"/>
              <a:t>18/02/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312D547-B736-904F-9F17-01528DB650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12D4243-4D6C-A24B-B7CF-5B5C03383D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7B667A-012E-6D45-A218-866B42A278EA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27551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Una captura de pantalla de un celular&#10;&#10;Descripción generada automáticamente">
            <a:extLst>
              <a:ext uri="{FF2B5EF4-FFF2-40B4-BE49-F238E27FC236}">
                <a16:creationId xmlns:a16="http://schemas.microsoft.com/office/drawing/2014/main" id="{174C202B-DDDE-2F4F-A7A8-5C3C270299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2650" y="609600"/>
            <a:ext cx="5346700" cy="5638800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56078F2D-AED7-6B40-A018-BD7ADB9150AF}"/>
              </a:ext>
            </a:extLst>
          </p:cNvPr>
          <p:cNvSpPr/>
          <p:nvPr/>
        </p:nvSpPr>
        <p:spPr>
          <a:xfrm>
            <a:off x="3245593" y="6135270"/>
            <a:ext cx="6476104" cy="4160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verall survival for AML calculated with the open cohort. </a:t>
            </a:r>
          </a:p>
        </p:txBody>
      </p:sp>
    </p:spTree>
    <p:extLst>
      <p:ext uri="{BB962C8B-B14F-4D97-AF65-F5344CB8AC3E}">
        <p14:creationId xmlns:p14="http://schemas.microsoft.com/office/powerpoint/2010/main" val="696943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Una captura de pantalla de un celular&#10;&#10;Descripción generada automáticamente">
            <a:extLst>
              <a:ext uri="{FF2B5EF4-FFF2-40B4-BE49-F238E27FC236}">
                <a16:creationId xmlns:a16="http://schemas.microsoft.com/office/drawing/2014/main" id="{93B6D8FD-A549-6248-860C-83B8CABBEF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7250" y="615950"/>
            <a:ext cx="5397500" cy="5626100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CC71E41E-08BE-3F43-AD9B-5D2C70385E4B}"/>
              </a:ext>
            </a:extLst>
          </p:cNvPr>
          <p:cNvSpPr/>
          <p:nvPr/>
        </p:nvSpPr>
        <p:spPr>
          <a:xfrm>
            <a:off x="1139815" y="6158920"/>
            <a:ext cx="10920513" cy="4160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</a:t>
            </a:r>
            <a:r>
              <a:rPr lang="en-US" sz="16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verall survival for AML calculated with the date and vital state of the last record in the medical record. </a:t>
            </a:r>
          </a:p>
        </p:txBody>
      </p:sp>
    </p:spTree>
    <p:extLst>
      <p:ext uri="{BB962C8B-B14F-4D97-AF65-F5344CB8AC3E}">
        <p14:creationId xmlns:p14="http://schemas.microsoft.com/office/powerpoint/2010/main" val="11091568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8</Words>
  <Application>Microsoft Macintosh PowerPoint</Application>
  <PresentationFormat>Panorámica</PresentationFormat>
  <Paragraphs>2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icardo Andrés Ballesteros Ramírez</dc:creator>
  <cp:lastModifiedBy>Ricardo Ballesteros</cp:lastModifiedBy>
  <cp:revision>4</cp:revision>
  <dcterms:created xsi:type="dcterms:W3CDTF">2020-02-10T20:35:03Z</dcterms:created>
  <dcterms:modified xsi:type="dcterms:W3CDTF">2020-02-18T16:22:01Z</dcterms:modified>
</cp:coreProperties>
</file>